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07"/>
  </p:normalViewPr>
  <p:slideViewPr>
    <p:cSldViewPr snapToGrid="0" snapToObjects="1">
      <p:cViewPr varScale="1">
        <p:scale>
          <a:sx n="124" d="100"/>
          <a:sy n="124" d="100"/>
        </p:scale>
        <p:origin x="6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45DCF2-A38C-9044-BD10-0E2E905023FB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18BE61-4637-C649-BDB4-C2FBC4C5632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595151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18BE61-4637-C649-BDB4-C2FBC4C56323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288151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B240C0-816D-974E-A471-951D38C43C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8CD26AF-A9ED-3941-BD06-C47DCDA9FC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B8B285-0BE3-C840-9889-F5A71BD28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41A3D-04DE-BE40-A580-3EFA723D8B3A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7B5C8CA-EFE5-DA49-815E-9D73A443C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8FADEA-D60F-5744-81D4-DFE142BFB1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57286-9A3E-A84B-A636-ABEB875131F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86527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9D140D-D925-2C49-BAFF-31A8A7EB24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D584C18-ACD7-374A-99F8-D5054B4777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407280D-C65B-EB4D-853A-2115C327E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41A3D-04DE-BE40-A580-3EFA723D8B3A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AC749CC-5124-8C4F-B8AD-6EA99ADDE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0D62185-B2F0-8542-A8BD-BF41C69CFF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57286-9A3E-A84B-A636-ABEB875131F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70009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9B05F2C-54DF-E848-B51F-4BF9E58398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CDBDEE9-543C-B14A-8B7A-54455CC393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A6E9781-7917-2C4E-901A-E338C74D4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41A3D-04DE-BE40-A580-3EFA723D8B3A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3CD737-09A9-BC4B-9F7E-3370A1FB9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0A1ED36-D634-9A44-AEE1-3EBAD7B5B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57286-9A3E-A84B-A636-ABEB875131F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23318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863929-DA63-4C43-ABB5-FAF11DFE32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A82996E-D2B8-EA44-B6DF-BE6F0256A2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90C7893-E4FE-AF4A-9AC4-4F364D0B57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41A3D-04DE-BE40-A580-3EFA723D8B3A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208B753-3864-6047-8269-F89FB88FDB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B79627-C3B9-7F4C-8895-01C02C39F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57286-9A3E-A84B-A636-ABEB875131F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18686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E9E110-5BE9-2742-BCE3-0CD258E869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42738D7-236D-C845-A71F-B7EA1030F3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1D2277-A028-F249-A56D-6B73C18D6C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41A3D-04DE-BE40-A580-3EFA723D8B3A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AD4629-C7BC-A04A-B299-5C33FDF632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C8BCF88-B419-E44B-8650-75DF41A0B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57286-9A3E-A84B-A636-ABEB875131F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608469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E3D940-39DA-8443-951D-1D06EE21BA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C6D432D-43AB-A64D-A38D-E580A4A8D7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E82EA6C-9FED-2244-A751-0FF67E0A6E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434B8D2-1E3B-E844-B82C-71F067381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41A3D-04DE-BE40-A580-3EFA723D8B3A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FBA1B04-2366-874B-A410-2D1E1FE65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F7C2268-46FA-3D4B-AFF8-529D802EB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57286-9A3E-A84B-A636-ABEB875131F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12426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A12382-A9BA-574B-9909-AF28C96EDF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A6C70E6-3D01-AA48-A39F-071449A834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8D3BF2D-8D8D-A246-B5C5-10F4B7BC99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2567387-8230-964B-90CE-04AA306998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7BBDBF3-E4BD-854F-BC48-8F186BF43E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CD3F408-DFB8-0D46-861D-670CF879C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41A3D-04DE-BE40-A580-3EFA723D8B3A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42D1270-DFF4-9A48-AA21-46C9E8BCDE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158E115-44A1-C64C-8703-81DE2AD4D1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57286-9A3E-A84B-A636-ABEB875131F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71100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9884E2-D7C0-CB4E-8805-E3997580D6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C79BBFB-BC4E-5C45-A29E-34EC620FF8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41A3D-04DE-BE40-A580-3EFA723D8B3A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1128B8A-29EB-CA42-896D-0CABE1A6D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71E2606-64E0-CB47-85B0-21CD0FAD7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57286-9A3E-A84B-A636-ABEB875131F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577703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E75E58F-CBCB-944F-8137-478C3CC93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41A3D-04DE-BE40-A580-3EFA723D8B3A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1207D6E-3BD1-2E41-86B3-E2E32E70F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5616925-BF1B-9446-A3F1-E3619402D7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57286-9A3E-A84B-A636-ABEB875131F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5885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29E989-4CC6-EB49-AAE3-4D4BE796B7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99659D7-CA76-C642-82C2-701ACADEB2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E6D2B6F-2CBC-4A4C-A5FE-2826C3A2D6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9D66113-586A-3045-BF6F-2F835D109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41A3D-04DE-BE40-A580-3EFA723D8B3A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44C6B29-5EAB-EE4E-80F9-C7CAF68F22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1AB4892-C5EB-2F48-9BD2-206916623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57286-9A3E-A84B-A636-ABEB875131F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15658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DE0CE5-E22B-3044-985F-451D96C62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C67C70D-C7B8-744D-AA04-6D45E18644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5F18F70-4D74-574D-BD4B-C5A15E68F2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10A23AC-47C8-F84A-91A8-E226239796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41A3D-04DE-BE40-A580-3EFA723D8B3A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C28ED1-38C8-9A43-82AF-B00AF760B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4D2550C-B6C0-2249-9C97-5013F483B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57286-9A3E-A84B-A636-ABEB875131F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697800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8364917-AAC8-5549-8BD4-1CE99FD755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AF86DEA-BACC-724B-A378-F16216C99A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725AA4-8339-3B48-AF60-F63D486485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541A3D-04DE-BE40-A580-3EFA723D8B3A}" type="datetimeFigureOut">
              <a:rPr kumimoji="1" lang="zh-CN" altLang="en-US" smtClean="0"/>
              <a:t>2022/8/2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0E0CA3A-1FF5-AD42-B55E-7592BD1EB1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3E7EC46-A57A-904D-ACB2-29B334E6CC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657286-9A3E-A84B-A636-ABEB875131FE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15644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7B32DF2-EB55-D749-9777-77EFF59BFC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7066" y="719137"/>
            <a:ext cx="5244349" cy="516255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DFA5B88-6275-B446-9DA0-84D1B005A2C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47765" y="829864"/>
            <a:ext cx="5191125" cy="494109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86CF86F1-9E1C-3942-AD0B-27DA5262A81E}"/>
              </a:ext>
            </a:extLst>
          </p:cNvPr>
          <p:cNvSpPr txBox="1"/>
          <p:nvPr/>
        </p:nvSpPr>
        <p:spPr>
          <a:xfrm>
            <a:off x="465436" y="966038"/>
            <a:ext cx="913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1FE72DD-25A8-464D-9F16-8407E2960AA6}"/>
              </a:ext>
            </a:extLst>
          </p:cNvPr>
          <p:cNvSpPr txBox="1"/>
          <p:nvPr/>
        </p:nvSpPr>
        <p:spPr>
          <a:xfrm>
            <a:off x="6096000" y="966305"/>
            <a:ext cx="9137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F8EE3749-E881-DB46-8454-8AC762F945F8}"/>
              </a:ext>
            </a:extLst>
          </p:cNvPr>
          <p:cNvSpPr txBox="1"/>
          <p:nvPr/>
        </p:nvSpPr>
        <p:spPr>
          <a:xfrm>
            <a:off x="1147831" y="5778114"/>
            <a:ext cx="417418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CA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n bacterial community was compared among different treatments </a:t>
            </a:r>
            <a:endParaRPr lang="zh-CN" altLang="en-US" sz="1200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BFA68C3-6C46-914E-9C26-3D84E970EF57}"/>
              </a:ext>
            </a:extLst>
          </p:cNvPr>
          <p:cNvSpPr txBox="1"/>
          <p:nvPr/>
        </p:nvSpPr>
        <p:spPr>
          <a:xfrm>
            <a:off x="6645708" y="5801781"/>
            <a:ext cx="417418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CA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n archaeal community was compared among different treatments 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826203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3</Words>
  <Application>Microsoft Macintosh PowerPoint</Application>
  <PresentationFormat>宽屏</PresentationFormat>
  <Paragraphs>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User</dc:creator>
  <cp:lastModifiedBy>fred win</cp:lastModifiedBy>
  <cp:revision>5</cp:revision>
  <dcterms:created xsi:type="dcterms:W3CDTF">2021-07-18T11:30:38Z</dcterms:created>
  <dcterms:modified xsi:type="dcterms:W3CDTF">2022-08-22T22:50:14Z</dcterms:modified>
</cp:coreProperties>
</file>